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119813" cy="3600450"/>
  <p:notesSz cx="6858000" cy="9144000"/>
  <p:defaultTextStyle>
    <a:defPPr>
      <a:defRPr lang="ko-KR"/>
    </a:defPPr>
    <a:lvl1pPr marL="0" algn="l" defTabSz="91432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66" algn="l" defTabSz="91432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29" algn="l" defTabSz="91432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495" algn="l" defTabSz="91432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59" algn="l" defTabSz="91432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825" algn="l" defTabSz="91432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988" algn="l" defTabSz="91432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154" algn="l" defTabSz="91432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318" algn="l" defTabSz="91432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34" userDrawn="1">
          <p15:clr>
            <a:srgbClr val="A4A3A4"/>
          </p15:clr>
        </p15:guide>
        <p15:guide id="2" pos="19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7" autoAdjust="0"/>
    <p:restoredTop sz="94660"/>
  </p:normalViewPr>
  <p:slideViewPr>
    <p:cSldViewPr snapToGrid="0" showGuides="1">
      <p:cViewPr varScale="1">
        <p:scale>
          <a:sx n="122" d="100"/>
          <a:sy n="122" d="100"/>
        </p:scale>
        <p:origin x="414" y="102"/>
      </p:cViewPr>
      <p:guideLst>
        <p:guide orient="horz" pos="1134"/>
        <p:guide pos="19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64977" y="589241"/>
            <a:ext cx="4589860" cy="1253490"/>
          </a:xfrm>
        </p:spPr>
        <p:txBody>
          <a:bodyPr anchor="b"/>
          <a:lstStyle>
            <a:lvl1pPr algn="ctr">
              <a:defRPr sz="301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1891070"/>
            <a:ext cx="4589860" cy="869275"/>
          </a:xfrm>
        </p:spPr>
        <p:txBody>
          <a:bodyPr/>
          <a:lstStyle>
            <a:lvl1pPr marL="0" indent="0" algn="ctr">
              <a:buNone/>
              <a:defRPr sz="1205"/>
            </a:lvl1pPr>
            <a:lvl2pPr marL="229514" indent="0" algn="ctr">
              <a:buNone/>
              <a:defRPr sz="1004"/>
            </a:lvl2pPr>
            <a:lvl3pPr marL="459029" indent="0" algn="ctr">
              <a:buNone/>
              <a:defRPr sz="904"/>
            </a:lvl3pPr>
            <a:lvl4pPr marL="688543" indent="0" algn="ctr">
              <a:buNone/>
              <a:defRPr sz="803"/>
            </a:lvl4pPr>
            <a:lvl5pPr marL="918058" indent="0" algn="ctr">
              <a:buNone/>
              <a:defRPr sz="803"/>
            </a:lvl5pPr>
            <a:lvl6pPr marL="1147572" indent="0" algn="ctr">
              <a:buNone/>
              <a:defRPr sz="803"/>
            </a:lvl6pPr>
            <a:lvl7pPr marL="1377086" indent="0" algn="ctr">
              <a:buNone/>
              <a:defRPr sz="803"/>
            </a:lvl7pPr>
            <a:lvl8pPr marL="1606601" indent="0" algn="ctr">
              <a:buNone/>
              <a:defRPr sz="803"/>
            </a:lvl8pPr>
            <a:lvl9pPr marL="1836115" indent="0" algn="ctr">
              <a:buNone/>
              <a:defRPr sz="803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B7343-F953-4888-8974-FC926BF45C04}" type="datetimeFigureOut">
              <a:rPr lang="ko-KR" altLang="en-US" smtClean="0"/>
              <a:t>2020-1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30967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B7343-F953-4888-8974-FC926BF45C04}" type="datetimeFigureOut">
              <a:rPr lang="ko-KR" altLang="en-US" smtClean="0"/>
              <a:t>2020-1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9497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191691"/>
            <a:ext cx="1319585" cy="305121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7" y="191691"/>
            <a:ext cx="3882256" cy="305121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B7343-F953-4888-8974-FC926BF45C04}" type="datetimeFigureOut">
              <a:rPr lang="ko-KR" altLang="en-US" smtClean="0"/>
              <a:t>2020-1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66584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B7343-F953-4888-8974-FC926BF45C04}" type="datetimeFigureOut">
              <a:rPr lang="ko-KR" altLang="en-US" smtClean="0"/>
              <a:t>2020-1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751459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897613"/>
            <a:ext cx="5278339" cy="1497687"/>
          </a:xfrm>
        </p:spPr>
        <p:txBody>
          <a:bodyPr anchor="b"/>
          <a:lstStyle>
            <a:lvl1pPr>
              <a:defRPr sz="301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2409468"/>
            <a:ext cx="5278339" cy="787598"/>
          </a:xfrm>
        </p:spPr>
        <p:txBody>
          <a:bodyPr/>
          <a:lstStyle>
            <a:lvl1pPr marL="0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1pPr>
            <a:lvl2pPr marL="229514" indent="0">
              <a:buNone/>
              <a:defRPr sz="1004">
                <a:solidFill>
                  <a:schemeClr val="tx1">
                    <a:tint val="75000"/>
                  </a:schemeClr>
                </a:solidFill>
              </a:defRPr>
            </a:lvl2pPr>
            <a:lvl3pPr marL="459029" indent="0">
              <a:buNone/>
              <a:defRPr sz="904">
                <a:solidFill>
                  <a:schemeClr val="tx1">
                    <a:tint val="75000"/>
                  </a:schemeClr>
                </a:solidFill>
              </a:defRPr>
            </a:lvl3pPr>
            <a:lvl4pPr marL="688543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4pPr>
            <a:lvl5pPr marL="918058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5pPr>
            <a:lvl6pPr marL="1147572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6pPr>
            <a:lvl7pPr marL="1377086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7pPr>
            <a:lvl8pPr marL="1606601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8pPr>
            <a:lvl9pPr marL="1836115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B7343-F953-4888-8974-FC926BF45C04}" type="datetimeFigureOut">
              <a:rPr lang="ko-KR" altLang="en-US" smtClean="0"/>
              <a:t>2020-1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1337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958453"/>
            <a:ext cx="2600921" cy="228445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958453"/>
            <a:ext cx="2600921" cy="228445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B7343-F953-4888-8974-FC926BF45C04}" type="datetimeFigureOut">
              <a:rPr lang="ko-KR" altLang="en-US" smtClean="0"/>
              <a:t>2020-1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69834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191691"/>
            <a:ext cx="5278339" cy="695921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4" y="882610"/>
            <a:ext cx="2588968" cy="432554"/>
          </a:xfrm>
        </p:spPr>
        <p:txBody>
          <a:bodyPr anchor="b"/>
          <a:lstStyle>
            <a:lvl1pPr marL="0" indent="0">
              <a:buNone/>
              <a:defRPr sz="1205" b="1"/>
            </a:lvl1pPr>
            <a:lvl2pPr marL="229514" indent="0">
              <a:buNone/>
              <a:defRPr sz="1004" b="1"/>
            </a:lvl2pPr>
            <a:lvl3pPr marL="459029" indent="0">
              <a:buNone/>
              <a:defRPr sz="904" b="1"/>
            </a:lvl3pPr>
            <a:lvl4pPr marL="688543" indent="0">
              <a:buNone/>
              <a:defRPr sz="803" b="1"/>
            </a:lvl4pPr>
            <a:lvl5pPr marL="918058" indent="0">
              <a:buNone/>
              <a:defRPr sz="803" b="1"/>
            </a:lvl5pPr>
            <a:lvl6pPr marL="1147572" indent="0">
              <a:buNone/>
              <a:defRPr sz="803" b="1"/>
            </a:lvl6pPr>
            <a:lvl7pPr marL="1377086" indent="0">
              <a:buNone/>
              <a:defRPr sz="803" b="1"/>
            </a:lvl7pPr>
            <a:lvl8pPr marL="1606601" indent="0">
              <a:buNone/>
              <a:defRPr sz="803" b="1"/>
            </a:lvl8pPr>
            <a:lvl9pPr marL="1836115" indent="0">
              <a:buNone/>
              <a:defRPr sz="803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4" y="1315164"/>
            <a:ext cx="2588968" cy="193440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882610"/>
            <a:ext cx="2601718" cy="432554"/>
          </a:xfrm>
        </p:spPr>
        <p:txBody>
          <a:bodyPr anchor="b"/>
          <a:lstStyle>
            <a:lvl1pPr marL="0" indent="0">
              <a:buNone/>
              <a:defRPr sz="1205" b="1"/>
            </a:lvl1pPr>
            <a:lvl2pPr marL="229514" indent="0">
              <a:buNone/>
              <a:defRPr sz="1004" b="1"/>
            </a:lvl2pPr>
            <a:lvl3pPr marL="459029" indent="0">
              <a:buNone/>
              <a:defRPr sz="904" b="1"/>
            </a:lvl3pPr>
            <a:lvl4pPr marL="688543" indent="0">
              <a:buNone/>
              <a:defRPr sz="803" b="1"/>
            </a:lvl4pPr>
            <a:lvl5pPr marL="918058" indent="0">
              <a:buNone/>
              <a:defRPr sz="803" b="1"/>
            </a:lvl5pPr>
            <a:lvl6pPr marL="1147572" indent="0">
              <a:buNone/>
              <a:defRPr sz="803" b="1"/>
            </a:lvl6pPr>
            <a:lvl7pPr marL="1377086" indent="0">
              <a:buNone/>
              <a:defRPr sz="803" b="1"/>
            </a:lvl7pPr>
            <a:lvl8pPr marL="1606601" indent="0">
              <a:buNone/>
              <a:defRPr sz="803" b="1"/>
            </a:lvl8pPr>
            <a:lvl9pPr marL="1836115" indent="0">
              <a:buNone/>
              <a:defRPr sz="803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1315164"/>
            <a:ext cx="2601718" cy="193440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B7343-F953-4888-8974-FC926BF45C04}" type="datetimeFigureOut">
              <a:rPr lang="ko-KR" altLang="en-US" smtClean="0"/>
              <a:t>2020-11-0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26860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B7343-F953-4888-8974-FC926BF45C04}" type="datetimeFigureOut">
              <a:rPr lang="ko-KR" altLang="en-US" smtClean="0"/>
              <a:t>2020-11-0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74499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B7343-F953-4888-8974-FC926BF45C04}" type="datetimeFigureOut">
              <a:rPr lang="ko-KR" altLang="en-US" smtClean="0"/>
              <a:t>2020-11-0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386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240030"/>
            <a:ext cx="1973799" cy="840105"/>
          </a:xfrm>
        </p:spPr>
        <p:txBody>
          <a:bodyPr anchor="b"/>
          <a:lstStyle>
            <a:lvl1pPr>
              <a:defRPr sz="1606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518398"/>
            <a:ext cx="3098155" cy="2558653"/>
          </a:xfrm>
        </p:spPr>
        <p:txBody>
          <a:bodyPr/>
          <a:lstStyle>
            <a:lvl1pPr>
              <a:defRPr sz="1606"/>
            </a:lvl1pPr>
            <a:lvl2pPr>
              <a:defRPr sz="1406"/>
            </a:lvl2pPr>
            <a:lvl3pPr>
              <a:defRPr sz="1205"/>
            </a:lvl3pPr>
            <a:lvl4pPr>
              <a:defRPr sz="1004"/>
            </a:lvl4pPr>
            <a:lvl5pPr>
              <a:defRPr sz="1004"/>
            </a:lvl5pPr>
            <a:lvl6pPr>
              <a:defRPr sz="1004"/>
            </a:lvl6pPr>
            <a:lvl7pPr>
              <a:defRPr sz="1004"/>
            </a:lvl7pPr>
            <a:lvl8pPr>
              <a:defRPr sz="1004"/>
            </a:lvl8pPr>
            <a:lvl9pPr>
              <a:defRPr sz="1004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080135"/>
            <a:ext cx="1973799" cy="2001084"/>
          </a:xfrm>
        </p:spPr>
        <p:txBody>
          <a:bodyPr/>
          <a:lstStyle>
            <a:lvl1pPr marL="0" indent="0">
              <a:buNone/>
              <a:defRPr sz="803"/>
            </a:lvl1pPr>
            <a:lvl2pPr marL="229514" indent="0">
              <a:buNone/>
              <a:defRPr sz="703"/>
            </a:lvl2pPr>
            <a:lvl3pPr marL="459029" indent="0">
              <a:buNone/>
              <a:defRPr sz="602"/>
            </a:lvl3pPr>
            <a:lvl4pPr marL="688543" indent="0">
              <a:buNone/>
              <a:defRPr sz="502"/>
            </a:lvl4pPr>
            <a:lvl5pPr marL="918058" indent="0">
              <a:buNone/>
              <a:defRPr sz="502"/>
            </a:lvl5pPr>
            <a:lvl6pPr marL="1147572" indent="0">
              <a:buNone/>
              <a:defRPr sz="502"/>
            </a:lvl6pPr>
            <a:lvl7pPr marL="1377086" indent="0">
              <a:buNone/>
              <a:defRPr sz="502"/>
            </a:lvl7pPr>
            <a:lvl8pPr marL="1606601" indent="0">
              <a:buNone/>
              <a:defRPr sz="502"/>
            </a:lvl8pPr>
            <a:lvl9pPr marL="1836115" indent="0">
              <a:buNone/>
              <a:defRPr sz="502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B7343-F953-4888-8974-FC926BF45C04}" type="datetimeFigureOut">
              <a:rPr lang="ko-KR" altLang="en-US" smtClean="0"/>
              <a:t>2020-1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485385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240030"/>
            <a:ext cx="1973799" cy="840105"/>
          </a:xfrm>
        </p:spPr>
        <p:txBody>
          <a:bodyPr anchor="b"/>
          <a:lstStyle>
            <a:lvl1pPr>
              <a:defRPr sz="1606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518398"/>
            <a:ext cx="3098155" cy="2558653"/>
          </a:xfrm>
        </p:spPr>
        <p:txBody>
          <a:bodyPr anchor="t"/>
          <a:lstStyle>
            <a:lvl1pPr marL="0" indent="0">
              <a:buNone/>
              <a:defRPr sz="1606"/>
            </a:lvl1pPr>
            <a:lvl2pPr marL="229514" indent="0">
              <a:buNone/>
              <a:defRPr sz="1406"/>
            </a:lvl2pPr>
            <a:lvl3pPr marL="459029" indent="0">
              <a:buNone/>
              <a:defRPr sz="1205"/>
            </a:lvl3pPr>
            <a:lvl4pPr marL="688543" indent="0">
              <a:buNone/>
              <a:defRPr sz="1004"/>
            </a:lvl4pPr>
            <a:lvl5pPr marL="918058" indent="0">
              <a:buNone/>
              <a:defRPr sz="1004"/>
            </a:lvl5pPr>
            <a:lvl6pPr marL="1147572" indent="0">
              <a:buNone/>
              <a:defRPr sz="1004"/>
            </a:lvl6pPr>
            <a:lvl7pPr marL="1377086" indent="0">
              <a:buNone/>
              <a:defRPr sz="1004"/>
            </a:lvl7pPr>
            <a:lvl8pPr marL="1606601" indent="0">
              <a:buNone/>
              <a:defRPr sz="1004"/>
            </a:lvl8pPr>
            <a:lvl9pPr marL="1836115" indent="0">
              <a:buNone/>
              <a:defRPr sz="1004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080135"/>
            <a:ext cx="1973799" cy="2001084"/>
          </a:xfrm>
        </p:spPr>
        <p:txBody>
          <a:bodyPr/>
          <a:lstStyle>
            <a:lvl1pPr marL="0" indent="0">
              <a:buNone/>
              <a:defRPr sz="803"/>
            </a:lvl1pPr>
            <a:lvl2pPr marL="229514" indent="0">
              <a:buNone/>
              <a:defRPr sz="703"/>
            </a:lvl2pPr>
            <a:lvl3pPr marL="459029" indent="0">
              <a:buNone/>
              <a:defRPr sz="602"/>
            </a:lvl3pPr>
            <a:lvl4pPr marL="688543" indent="0">
              <a:buNone/>
              <a:defRPr sz="502"/>
            </a:lvl4pPr>
            <a:lvl5pPr marL="918058" indent="0">
              <a:buNone/>
              <a:defRPr sz="502"/>
            </a:lvl5pPr>
            <a:lvl6pPr marL="1147572" indent="0">
              <a:buNone/>
              <a:defRPr sz="502"/>
            </a:lvl6pPr>
            <a:lvl7pPr marL="1377086" indent="0">
              <a:buNone/>
              <a:defRPr sz="502"/>
            </a:lvl7pPr>
            <a:lvl8pPr marL="1606601" indent="0">
              <a:buNone/>
              <a:defRPr sz="502"/>
            </a:lvl8pPr>
            <a:lvl9pPr marL="1836115" indent="0">
              <a:buNone/>
              <a:defRPr sz="502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B7343-F953-4888-8974-FC926BF45C04}" type="datetimeFigureOut">
              <a:rPr lang="ko-KR" altLang="en-US" smtClean="0"/>
              <a:t>2020-1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4808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191691"/>
            <a:ext cx="5278339" cy="6959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958453"/>
            <a:ext cx="5278339" cy="22844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3337084"/>
            <a:ext cx="1376958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9B7343-F953-4888-8974-FC926BF45C04}" type="datetimeFigureOut">
              <a:rPr lang="ko-KR" altLang="en-US" smtClean="0"/>
              <a:t>2020-1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3337084"/>
            <a:ext cx="2065437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3337084"/>
            <a:ext cx="1376958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7F0378-95D1-4C6D-A694-C18FA8A94B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7684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459029" rtl="0" eaLnBrk="1" latinLnBrk="1" hangingPunct="1">
        <a:lnSpc>
          <a:spcPct val="90000"/>
        </a:lnSpc>
        <a:spcBef>
          <a:spcPct val="0"/>
        </a:spcBef>
        <a:buNone/>
        <a:defRPr sz="220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4757" indent="-114757" algn="l" defTabSz="459029" rtl="0" eaLnBrk="1" latinLnBrk="1" hangingPunct="1">
        <a:lnSpc>
          <a:spcPct val="90000"/>
        </a:lnSpc>
        <a:spcBef>
          <a:spcPts val="502"/>
        </a:spcBef>
        <a:buFont typeface="Arial" panose="020B0604020202020204" pitchFamily="34" charset="0"/>
        <a:buChar char="•"/>
        <a:defRPr sz="1406" kern="1200">
          <a:solidFill>
            <a:schemeClr val="tx1"/>
          </a:solidFill>
          <a:latin typeface="+mn-lt"/>
          <a:ea typeface="+mn-ea"/>
          <a:cs typeface="+mn-cs"/>
        </a:defRPr>
      </a:lvl1pPr>
      <a:lvl2pPr marL="344272" indent="-114757" algn="l" defTabSz="459029" rtl="0" eaLnBrk="1" latinLnBrk="1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573786" indent="-114757" algn="l" defTabSz="459029" rtl="0" eaLnBrk="1" latinLnBrk="1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1004" kern="1200">
          <a:solidFill>
            <a:schemeClr val="tx1"/>
          </a:solidFill>
          <a:latin typeface="+mn-lt"/>
          <a:ea typeface="+mn-ea"/>
          <a:cs typeface="+mn-cs"/>
        </a:defRPr>
      </a:lvl3pPr>
      <a:lvl4pPr marL="803300" indent="-114757" algn="l" defTabSz="459029" rtl="0" eaLnBrk="1" latinLnBrk="1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4pPr>
      <a:lvl5pPr marL="1032815" indent="-114757" algn="l" defTabSz="459029" rtl="0" eaLnBrk="1" latinLnBrk="1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5pPr>
      <a:lvl6pPr marL="1262329" indent="-114757" algn="l" defTabSz="459029" rtl="0" eaLnBrk="1" latinLnBrk="1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6pPr>
      <a:lvl7pPr marL="1491844" indent="-114757" algn="l" defTabSz="459029" rtl="0" eaLnBrk="1" latinLnBrk="1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7pPr>
      <a:lvl8pPr marL="1721358" indent="-114757" algn="l" defTabSz="459029" rtl="0" eaLnBrk="1" latinLnBrk="1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8pPr>
      <a:lvl9pPr marL="1950872" indent="-114757" algn="l" defTabSz="459029" rtl="0" eaLnBrk="1" latinLnBrk="1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9029" rtl="0" eaLnBrk="1" latinLnBrk="1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1pPr>
      <a:lvl2pPr marL="229514" algn="l" defTabSz="459029" rtl="0" eaLnBrk="1" latinLnBrk="1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2pPr>
      <a:lvl3pPr marL="459029" algn="l" defTabSz="459029" rtl="0" eaLnBrk="1" latinLnBrk="1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3pPr>
      <a:lvl4pPr marL="688543" algn="l" defTabSz="459029" rtl="0" eaLnBrk="1" latinLnBrk="1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4pPr>
      <a:lvl5pPr marL="918058" algn="l" defTabSz="459029" rtl="0" eaLnBrk="1" latinLnBrk="1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5pPr>
      <a:lvl6pPr marL="1147572" algn="l" defTabSz="459029" rtl="0" eaLnBrk="1" latinLnBrk="1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6pPr>
      <a:lvl7pPr marL="1377086" algn="l" defTabSz="459029" rtl="0" eaLnBrk="1" latinLnBrk="1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7pPr>
      <a:lvl8pPr marL="1606601" algn="l" defTabSz="459029" rtl="0" eaLnBrk="1" latinLnBrk="1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8pPr>
      <a:lvl9pPr marL="1836115" algn="l" defTabSz="459029" rtl="0" eaLnBrk="1" latinLnBrk="1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6326" y="252444"/>
            <a:ext cx="3827716" cy="2502261"/>
          </a:xfrm>
          <a:prstGeom prst="rect">
            <a:avLst/>
          </a:prstGeom>
        </p:spPr>
      </p:pic>
      <p:cxnSp>
        <p:nvCxnSpPr>
          <p:cNvPr id="6" name="직선 화살표 연결선 5"/>
          <p:cNvCxnSpPr/>
          <p:nvPr/>
        </p:nvCxnSpPr>
        <p:spPr>
          <a:xfrm flipH="1">
            <a:off x="3061324" y="984249"/>
            <a:ext cx="106247" cy="127497"/>
          </a:xfrm>
          <a:prstGeom prst="straightConnector1">
            <a:avLst/>
          </a:prstGeom>
          <a:ln>
            <a:solidFill>
              <a:srgbClr val="0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직사각형 7"/>
          <p:cNvSpPr/>
          <p:nvPr/>
        </p:nvSpPr>
        <p:spPr>
          <a:xfrm>
            <a:off x="3114449" y="806047"/>
            <a:ext cx="875561" cy="21589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chr06:8329287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25998" y="2917124"/>
            <a:ext cx="48706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1. Association signals for heading date on chromosome 6 by GWAS using all variants including InDels. </a:t>
            </a:r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 dots denote significant associations with HD ( </a:t>
            </a:r>
            <a:r>
              <a:rPr lang="en-US" altLang="ko-KR" sz="8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altLang="ko-KR" sz="800" i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≤</a:t>
            </a:r>
            <a:r>
              <a:rPr lang="en-US" altLang="ko-KR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80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35 </a:t>
            </a:r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x 10</a:t>
            </a:r>
            <a:r>
              <a:rPr lang="en-US" altLang="ko-KR" sz="8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6</a:t>
            </a:r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ko-KR" altLang="en-US" sz="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406770" y="753417"/>
            <a:ext cx="80021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Heading date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89653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565656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52</TotalTime>
  <Words>36</Words>
  <Application>Microsoft Office PowerPoint</Application>
  <PresentationFormat>사용자 지정</PresentationFormat>
  <Paragraphs>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장 수</dc:creator>
  <cp:lastModifiedBy>장 수</cp:lastModifiedBy>
  <cp:revision>10</cp:revision>
  <dcterms:created xsi:type="dcterms:W3CDTF">2020-05-21T15:13:16Z</dcterms:created>
  <dcterms:modified xsi:type="dcterms:W3CDTF">2020-11-06T06:36:08Z</dcterms:modified>
</cp:coreProperties>
</file>